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77724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 snapToObjects="1">
      <p:cViewPr varScale="1">
        <p:scale>
          <a:sx n="93" d="100"/>
          <a:sy n="93" d="100"/>
        </p:scale>
        <p:origin x="245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496484"/>
            <a:ext cx="6606540" cy="3183467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4802717"/>
            <a:ext cx="5829300" cy="2207683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5426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679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486834"/>
            <a:ext cx="1675924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486834"/>
            <a:ext cx="4930616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712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322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279653"/>
            <a:ext cx="6703695" cy="3803649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119286"/>
            <a:ext cx="6703695" cy="2000249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819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434167"/>
            <a:ext cx="330327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794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486836"/>
            <a:ext cx="670369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241551"/>
            <a:ext cx="3288089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340100"/>
            <a:ext cx="3288089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241551"/>
            <a:ext cx="3304282" cy="1098549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340100"/>
            <a:ext cx="3304282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8049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629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2019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316569"/>
            <a:ext cx="3934778" cy="6498167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943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09600"/>
            <a:ext cx="2506801" cy="213360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316569"/>
            <a:ext cx="3934778" cy="6498167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2743200"/>
            <a:ext cx="2506801" cy="5082117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941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486836"/>
            <a:ext cx="670369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434167"/>
            <a:ext cx="670369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46A36-4B67-AB48-AE75-46F1356E7678}" type="datetimeFigureOut">
              <a:rPr lang="en-US" smtClean="0"/>
              <a:t>2/21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8475136"/>
            <a:ext cx="262318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8475136"/>
            <a:ext cx="174879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4E6D7-0C58-1346-8F14-10050FE8D1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0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4882868-4454-FD40-BA86-87ECD1DFD4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3291" y="0"/>
            <a:ext cx="7065818" cy="914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30166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266DC47-9833-234E-BB26-B613C29A46AF}"/>
              </a:ext>
            </a:extLst>
          </p:cNvPr>
          <p:cNvSpPr/>
          <p:nvPr/>
        </p:nvSpPr>
        <p:spPr>
          <a:xfrm>
            <a:off x="396586" y="536782"/>
            <a:ext cx="6979228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libri" panose="020F0502020204030204" pitchFamily="34" charset="0"/>
              </a:rPr>
              <a:t>Supplementary Figure 4. Ventricle volume is associated with tumor volume. </a:t>
            </a:r>
            <a:r>
              <a:rPr lang="en-US" sz="1100" dirty="0">
                <a:latin typeface="Calibri" panose="020F0502020204030204" pitchFamily="34" charset="0"/>
              </a:rPr>
              <a:t>(A) Computed tomography (CT) image of a pup, aged 21 days, without hydrocephalus in which doming of the skull is not seen. (B) CT image of a pup, aged 21 days, with hydrocephalus and prominent doming of the skull. A- B scalebar = 1 cm. (C) Representative T1 post- contrast MRIs of 3 brain regions in an RCAS-based GEMMs of DIPG showing ventricle size (dotted line) and tumor (solid line) dissemination through the pons and midbrain 3 weeks post-injection with minimal (top row), moderate (middle row) and severe ventriculomegaly (bottom row). (D) Distribution of ventricle and tumor volumes. Ventricle volume was closely associated with tumor volume (n = 33; r = 0.67; p &lt; 0.0001; Linear regression analysis). C-D scalebar = 5 mm. </a:t>
            </a:r>
            <a:endParaRPr lang="en-US" sz="1100" dirty="0"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15167660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69</Words>
  <Application>Microsoft Macintosh PowerPoint</Application>
  <PresentationFormat>Custom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Shelei</dc:creator>
  <cp:lastModifiedBy>Pan, Shelei</cp:lastModifiedBy>
  <cp:revision>1</cp:revision>
  <dcterms:created xsi:type="dcterms:W3CDTF">2022-02-21T16:51:02Z</dcterms:created>
  <dcterms:modified xsi:type="dcterms:W3CDTF">2022-02-21T16:52:49Z</dcterms:modified>
</cp:coreProperties>
</file>